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  <p:sldId id="262" r:id="rId4"/>
    <p:sldId id="256" r:id="rId5"/>
    <p:sldId id="257" r:id="rId6"/>
    <p:sldId id="258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10" d="100"/>
          <a:sy n="110" d="100"/>
        </p:scale>
        <p:origin x="59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0D6C926-39BF-24E9-768E-18119BD6116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4898CBF2-80D5-F980-3C3F-A2F293E2275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BE65532-31CE-F014-3158-18754E602D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A5187-F9C2-474F-AA61-D46E4324AB33}" type="datetimeFigureOut">
              <a:rPr lang="zh-CN" altLang="en-US" smtClean="0"/>
              <a:t>2024/8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23C6B24-E094-56EA-3280-539D5E3A47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F174508-38F9-09F1-AD6C-E428908807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E581E-555C-4978-951D-D9A13AD9B2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60263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EE32AAE-2F61-298E-544F-BC07AB53E7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8DB8E81-769B-6D90-C737-EA6AE22312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08BFD05-CC13-DC40-97F5-80AB35D17D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A5187-F9C2-474F-AA61-D46E4324AB33}" type="datetimeFigureOut">
              <a:rPr lang="zh-CN" altLang="en-US" smtClean="0"/>
              <a:t>2024/8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772BB11-E852-3A92-1177-92E1B9207E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F179324-03C7-7C82-5913-5F539A0455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E581E-555C-4978-951D-D9A13AD9B2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18917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88F56E28-854D-075B-BCA2-34FD82FC9F9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D7C3F72-8331-0792-F236-41E0EC04CA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B291891-3F3B-44F3-93B7-5BDA996BC8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A5187-F9C2-474F-AA61-D46E4324AB33}" type="datetimeFigureOut">
              <a:rPr lang="zh-CN" altLang="en-US" smtClean="0"/>
              <a:t>2024/8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4A087F8-4383-5248-DC40-DDBEDDFA30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19C4473-B2A9-1C24-AA92-CF4F3E0AD1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E581E-555C-4978-951D-D9A13AD9B2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94214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3A63372-C460-E265-D8ED-123EB0FA87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691C43E-329B-4044-017E-66AF02F4188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8A646CF-7CD4-5FB9-8C27-81D0EF3A31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A5187-F9C2-474F-AA61-D46E4324AB33}" type="datetimeFigureOut">
              <a:rPr lang="zh-CN" altLang="en-US" smtClean="0"/>
              <a:t>2024/8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1435F96-9D69-BEAE-8525-BE8362AC59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63486FB-F438-AB01-87D3-33F5F1219B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E581E-555C-4978-951D-D9A13AD9B2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57178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7A9DE90-E424-C9DA-948F-4614DBB50F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1FA1F48-7136-757E-125F-C0EE65F752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BEE9D87-E9A2-C658-82B8-DE03992714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A5187-F9C2-474F-AA61-D46E4324AB33}" type="datetimeFigureOut">
              <a:rPr lang="zh-CN" altLang="en-US" smtClean="0"/>
              <a:t>2024/8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85BA6FA-2DA1-C05E-FE57-45A271DAD0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4EF9E38-71A9-ECE5-5A38-7B4E2ACA47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E581E-555C-4978-951D-D9A13AD9B2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24657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1B11F43-B990-48F4-C247-1CAB84424F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B174546-8A6E-EF9D-230C-09B2A43F727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043D443-B363-26B6-FE1C-167D617FF5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22ECFE9-6973-C5D0-C0EB-7160588867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A5187-F9C2-474F-AA61-D46E4324AB33}" type="datetimeFigureOut">
              <a:rPr lang="zh-CN" altLang="en-US" smtClean="0"/>
              <a:t>2024/8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E713CA5-6979-EC6E-A508-BAAD7BC709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EDEFF70-C4C5-77D8-BB4D-7CC4DD69CA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E581E-555C-4978-951D-D9A13AD9B2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69954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1669757-CC7A-9CA7-BEE5-26F92E0F58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63AF965-2DDD-2543-1EAA-4F68B4182C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DC3AC45-41B7-6758-7890-42A6A052DA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6125731-2B98-5D6C-3C6C-B06A2478730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06C389E-F76E-3DF4-1B3A-570BCA7BFA5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6208440-8FC7-8E6F-128F-F92FB791DD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A5187-F9C2-474F-AA61-D46E4324AB33}" type="datetimeFigureOut">
              <a:rPr lang="zh-CN" altLang="en-US" smtClean="0"/>
              <a:t>2024/8/2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5DF1EE91-1A50-7D9A-DF49-6D088C9915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D24ADB8-469B-FE1C-E91C-B25E84403C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E581E-555C-4978-951D-D9A13AD9B2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53464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70B76BB-7086-DCF3-F244-55FB7D36A2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D89BB65-3C9E-1805-5EDD-AE3DB2775A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A5187-F9C2-474F-AA61-D46E4324AB33}" type="datetimeFigureOut">
              <a:rPr lang="zh-CN" altLang="en-US" smtClean="0"/>
              <a:t>2024/8/2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6DF390F-9216-49B0-7B9E-94FADA0800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84238C3-507C-242A-F1D8-366733ADF6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E581E-555C-4978-951D-D9A13AD9B2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5047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047A9D4-BC30-6E71-DD0B-069E8BCAAB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A5187-F9C2-474F-AA61-D46E4324AB33}" type="datetimeFigureOut">
              <a:rPr lang="zh-CN" altLang="en-US" smtClean="0"/>
              <a:t>2024/8/2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25E5C13-0A4A-5EAB-FA95-5B9CFFEF0C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3176FB55-8686-29BC-A612-F768DEBCE5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E581E-555C-4978-951D-D9A13AD9B2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00815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72D1076-083A-35AD-BE90-2B3A2306A0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93B08D2-C678-03FB-01CB-23007B2C347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CB19BEB-CE26-89FD-F70F-6EA072B8CD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DF532B5-5973-6576-B521-1D52ECEB4C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A5187-F9C2-474F-AA61-D46E4324AB33}" type="datetimeFigureOut">
              <a:rPr lang="zh-CN" altLang="en-US" smtClean="0"/>
              <a:t>2024/8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6CAE35F-D043-BBE9-5C61-8055F3A91E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CDEFE2A-7D23-A6CB-AE9B-6453751618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E581E-555C-4978-951D-D9A13AD9B2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145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37445FF-F315-3C66-936A-1D082F3B1D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EEF0425-2DF7-2CE7-2D02-44AD318C594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102211D-D22A-184D-5995-CCB35CE6E5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F5D10F4-7FAB-A513-9908-2CE69CB42B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A5187-F9C2-474F-AA61-D46E4324AB33}" type="datetimeFigureOut">
              <a:rPr lang="zh-CN" altLang="en-US" smtClean="0"/>
              <a:t>2024/8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811102C-BED1-0F0B-9C16-C4582126FA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2C9C70A-1951-3F1F-6DFD-7279D577AA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E581E-555C-4978-951D-D9A13AD9B2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22108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AB4F484-0846-5981-D407-0A35DE369E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6A67205-6207-08C0-35A0-465A824E09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9B5E584-2389-D667-7B10-062EA200F9B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C9A5187-F9C2-474F-AA61-D46E4324AB33}" type="datetimeFigureOut">
              <a:rPr lang="zh-CN" altLang="en-US" smtClean="0"/>
              <a:t>2024/8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51736CF-95A2-7577-5C60-84DB0DF6A37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0BDCACD-4817-0102-426F-CE773F22BFC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87E581E-555C-4978-951D-D9A13AD9B2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42470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 descr="图表, 图示, 箱线图&#10;&#10;描述已自动生成">
            <a:extLst>
              <a:ext uri="{FF2B5EF4-FFF2-40B4-BE49-F238E27FC236}">
                <a16:creationId xmlns:a16="http://schemas.microsoft.com/office/drawing/2014/main" id="{66F6F818-D9DB-D863-D2D6-692800C8573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8029" y="1495029"/>
            <a:ext cx="10275941" cy="3425314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9ADCB3F5-E257-783D-C2F5-15B83A32A47B}"/>
              </a:ext>
            </a:extLst>
          </p:cNvPr>
          <p:cNvSpPr txBox="1"/>
          <p:nvPr/>
        </p:nvSpPr>
        <p:spPr>
          <a:xfrm>
            <a:off x="4606833" y="5326628"/>
            <a:ext cx="29783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Meta-analysis result of Bard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7315658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图示, 示意图&#10;&#10;描述已自动生成">
            <a:extLst>
              <a:ext uri="{FF2B5EF4-FFF2-40B4-BE49-F238E27FC236}">
                <a16:creationId xmlns:a16="http://schemas.microsoft.com/office/drawing/2014/main" id="{7FD57A3D-4E70-8B52-1B08-F4047DFE87A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6203" y="765579"/>
            <a:ext cx="7079593" cy="5326842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F5492A9E-E03F-0C59-BB42-6713D048DDBC}"/>
              </a:ext>
            </a:extLst>
          </p:cNvPr>
          <p:cNvSpPr txBox="1"/>
          <p:nvPr/>
        </p:nvSpPr>
        <p:spPr>
          <a:xfrm>
            <a:off x="4223655" y="6171360"/>
            <a:ext cx="37446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Subgroup analysis result of GPT-3.5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6859094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图示, 示意图&#10;&#10;描述已自动生成">
            <a:extLst>
              <a:ext uri="{FF2B5EF4-FFF2-40B4-BE49-F238E27FC236}">
                <a16:creationId xmlns:a16="http://schemas.microsoft.com/office/drawing/2014/main" id="{E9EEDBA5-C647-F33F-FF46-6833E9FC050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5670" y="1047543"/>
            <a:ext cx="7620660" cy="4762913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42D6D946-75A5-B371-77B8-83337DF05522}"/>
              </a:ext>
            </a:extLst>
          </p:cNvPr>
          <p:cNvSpPr txBox="1"/>
          <p:nvPr/>
        </p:nvSpPr>
        <p:spPr>
          <a:xfrm>
            <a:off x="4223655" y="6171360"/>
            <a:ext cx="37446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 Light" panose="02010600030101010101" pitchFamily="2" charset="-122"/>
                <a:cs typeface="Times New Roman" panose="02020603050405020304" pitchFamily="18" charset="0"/>
              </a:rPr>
              <a:t>Subgroup analysis result of GPT-4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3176222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图表&#10;&#10;描述已自动生成">
            <a:extLst>
              <a:ext uri="{FF2B5EF4-FFF2-40B4-BE49-F238E27FC236}">
                <a16:creationId xmlns:a16="http://schemas.microsoft.com/office/drawing/2014/main" id="{21B394B5-A56A-8FA7-35D3-950E0B248BF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0074" y="1045028"/>
            <a:ext cx="10151851" cy="4158498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E4BEB131-CECD-3DEA-2AA2-2F3A63E9DA8E}"/>
              </a:ext>
            </a:extLst>
          </p:cNvPr>
          <p:cNvSpPr txBox="1"/>
          <p:nvPr/>
        </p:nvSpPr>
        <p:spPr>
          <a:xfrm>
            <a:off x="5615472" y="5318450"/>
            <a:ext cx="9610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PT-3.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762BCC52-319B-A30B-DBC3-A7A0A82299CA}"/>
              </a:ext>
            </a:extLst>
          </p:cNvPr>
          <p:cNvSpPr txBox="1"/>
          <p:nvPr/>
        </p:nvSpPr>
        <p:spPr>
          <a:xfrm>
            <a:off x="4167048" y="6119109"/>
            <a:ext cx="38578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 Light" panose="02010600030101010101" pitchFamily="2" charset="-122"/>
                <a:cs typeface="Times New Roman" panose="02020603050405020304" pitchFamily="18" charset="0"/>
              </a:rPr>
              <a:t>Sensitivity analysis result of GPT-3.5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44595500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图表&#10;&#10;中度可信度描述已自动生成">
            <a:extLst>
              <a:ext uri="{FF2B5EF4-FFF2-40B4-BE49-F238E27FC236}">
                <a16:creationId xmlns:a16="http://schemas.microsoft.com/office/drawing/2014/main" id="{D28A7470-7E37-441A-E1B6-410B7AD3FB8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8534" y="1205749"/>
            <a:ext cx="10854932" cy="4446501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B0688E09-4F07-A346-2F04-968CA1EB1811}"/>
              </a:ext>
            </a:extLst>
          </p:cNvPr>
          <p:cNvSpPr txBox="1"/>
          <p:nvPr/>
        </p:nvSpPr>
        <p:spPr>
          <a:xfrm>
            <a:off x="5615472" y="5318450"/>
            <a:ext cx="9610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PT-4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0EC31BCD-5A6D-4419-5FFA-BA3FFFDD3982}"/>
              </a:ext>
            </a:extLst>
          </p:cNvPr>
          <p:cNvSpPr txBox="1"/>
          <p:nvPr/>
        </p:nvSpPr>
        <p:spPr>
          <a:xfrm>
            <a:off x="4167048" y="6119109"/>
            <a:ext cx="38578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 Light" panose="02010600030101010101" pitchFamily="2" charset="-122"/>
                <a:cs typeface="Times New Roman" panose="02020603050405020304" pitchFamily="18" charset="0"/>
              </a:rPr>
              <a:t>Sensitivity analysis result of GPT-4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85133858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图表, 箱线图&#10;&#10;描述已自动生成">
            <a:extLst>
              <a:ext uri="{FF2B5EF4-FFF2-40B4-BE49-F238E27FC236}">
                <a16:creationId xmlns:a16="http://schemas.microsoft.com/office/drawing/2014/main" id="{9F6EDEA1-FDE6-99E1-48C1-633D87EE043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955" y="1144477"/>
            <a:ext cx="11154090" cy="4569045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AC2AE415-7000-4715-7322-E16DB03B85ED}"/>
              </a:ext>
            </a:extLst>
          </p:cNvPr>
          <p:cNvSpPr txBox="1"/>
          <p:nvPr/>
        </p:nvSpPr>
        <p:spPr>
          <a:xfrm>
            <a:off x="5615472" y="5318450"/>
            <a:ext cx="9610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Bard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C8D83844-E184-7725-438A-87425C64B7B3}"/>
              </a:ext>
            </a:extLst>
          </p:cNvPr>
          <p:cNvSpPr txBox="1"/>
          <p:nvPr/>
        </p:nvSpPr>
        <p:spPr>
          <a:xfrm>
            <a:off x="4167048" y="6119109"/>
            <a:ext cx="38578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 Light" panose="02010600030101010101" pitchFamily="2" charset="-122"/>
                <a:cs typeface="Times New Roman" panose="02020603050405020304" pitchFamily="18" charset="0"/>
              </a:rPr>
              <a:t>Sensitivity analysis result of Bard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6656294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38</Words>
  <Application>Microsoft Office PowerPoint</Application>
  <PresentationFormat>宽屏</PresentationFormat>
  <Paragraphs>9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1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IU　Mingxin</dc:creator>
  <cp:lastModifiedBy>LIU　Mingxin</cp:lastModifiedBy>
  <cp:revision>4</cp:revision>
  <dcterms:created xsi:type="dcterms:W3CDTF">2024-08-03T09:48:01Z</dcterms:created>
  <dcterms:modified xsi:type="dcterms:W3CDTF">2024-08-23T11:14:03Z</dcterms:modified>
</cp:coreProperties>
</file>